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625E07-DBF7-48B8-833A-2B24E12202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A6D8A-A1D4-45AD-A33D-8039CCAB60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83223-125D-4863-8392-EE7F1DF9FB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A4F08-B442-4C22-AB07-63407BAF3D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AFF29-95CF-4953-8A83-706BA66FD5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A92BA-430D-4D4A-8FEE-9312EFFD36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3B079-BF86-4EE6-8446-309D9DEE7C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EA468-3C85-4A41-8310-4EC2C5A5FF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2F2B9-FBB8-4E05-9D71-8ED566A653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5150F5-F1AF-4816-B43A-A80CF80AAA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0BB53-F082-4E3C-9358-285CB0EF6A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31DA0-C059-40E0-B959-CD7401EFF9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29E0A5-27CF-4983-A849-7CD1CE3041D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482920" y="474840"/>
            <a:ext cx="3387960" cy="5120280"/>
            <a:chOff x="2482920" y="474840"/>
            <a:chExt cx="3387960" cy="5120280"/>
          </a:xfrm>
        </p:grpSpPr>
        <p:sp>
          <p:nvSpPr>
            <p:cNvPr id="42" name=""/>
            <p:cNvSpPr/>
            <p:nvPr/>
          </p:nvSpPr>
          <p:spPr>
            <a:xfrm>
              <a:off x="2712960" y="47484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482920" y="609480"/>
              <a:ext cx="232920" cy="2262240"/>
            </a:xfrm>
            <a:custGeom>
              <a:avLst/>
              <a:gdLst/>
              <a:ahLst/>
              <a:rect l="l" t="t" r="r" b="b"/>
              <a:pathLst>
                <a:path w="57" h="1425">
                  <a:moveTo>
                    <a:pt x="0" y="1425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712960" y="74448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8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482920" y="879480"/>
              <a:ext cx="232920" cy="2127240"/>
            </a:xfrm>
            <a:custGeom>
              <a:avLst/>
              <a:gdLst/>
              <a:ahLst/>
              <a:rect l="l" t="t" r="r" b="b"/>
              <a:pathLst>
                <a:path w="57" h="1340">
                  <a:moveTo>
                    <a:pt x="0" y="1340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714040" y="101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482920" y="1149480"/>
              <a:ext cx="232920" cy="1992240"/>
            </a:xfrm>
            <a:custGeom>
              <a:avLst/>
              <a:gdLst/>
              <a:ahLst/>
              <a:rect l="l" t="t" r="r" b="b"/>
              <a:pathLst>
                <a:path w="57" h="1255">
                  <a:moveTo>
                    <a:pt x="0" y="1255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714040" y="128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482920" y="1419120"/>
              <a:ext cx="232920" cy="1857600"/>
            </a:xfrm>
            <a:custGeom>
              <a:avLst/>
              <a:gdLst/>
              <a:ahLst/>
              <a:rect l="l" t="t" r="r" b="b"/>
              <a:pathLst>
                <a:path w="57" h="1170">
                  <a:moveTo>
                    <a:pt x="0" y="1170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714040" y="155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6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482920" y="1690560"/>
              <a:ext cx="232920" cy="1720800"/>
            </a:xfrm>
            <a:custGeom>
              <a:avLst/>
              <a:gdLst/>
              <a:ahLst/>
              <a:rect l="l" t="t" r="r" b="b"/>
              <a:pathLst>
                <a:path w="57" h="1084">
                  <a:moveTo>
                    <a:pt x="0" y="1084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714040" y="182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4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482920" y="1960560"/>
              <a:ext cx="232920" cy="1585800"/>
            </a:xfrm>
            <a:custGeom>
              <a:avLst/>
              <a:gdLst/>
              <a:ahLst/>
              <a:rect l="l" t="t" r="r" b="b"/>
              <a:pathLst>
                <a:path w="57" h="999">
                  <a:moveTo>
                    <a:pt x="0" y="999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714040" y="209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482920" y="2230560"/>
              <a:ext cx="232920" cy="1450800"/>
            </a:xfrm>
            <a:custGeom>
              <a:avLst/>
              <a:gdLst/>
              <a:ahLst/>
              <a:rect l="l" t="t" r="r" b="b"/>
              <a:pathLst>
                <a:path w="57" h="914">
                  <a:moveTo>
                    <a:pt x="0" y="914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714040" y="236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482920" y="2500200"/>
              <a:ext cx="232920" cy="1316160"/>
            </a:xfrm>
            <a:custGeom>
              <a:avLst/>
              <a:gdLst/>
              <a:ahLst/>
              <a:rect l="l" t="t" r="r" b="b"/>
              <a:pathLst>
                <a:path w="57" h="829">
                  <a:moveTo>
                    <a:pt x="0" y="829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714040" y="263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482920" y="2770200"/>
              <a:ext cx="232920" cy="1181160"/>
            </a:xfrm>
            <a:custGeom>
              <a:avLst/>
              <a:gdLst/>
              <a:ahLst/>
              <a:rect l="l" t="t" r="r" b="b"/>
              <a:pathLst>
                <a:path w="57" h="744">
                  <a:moveTo>
                    <a:pt x="0" y="744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714040" y="290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88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482920" y="3040200"/>
              <a:ext cx="204480" cy="1046160"/>
            </a:xfrm>
            <a:custGeom>
              <a:avLst/>
              <a:gdLst/>
              <a:ahLst/>
              <a:rect l="l" t="t" r="r" b="b"/>
              <a:pathLst>
                <a:path w="50" h="659">
                  <a:moveTo>
                    <a:pt x="0" y="659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714040" y="317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9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482920" y="3309840"/>
              <a:ext cx="232920" cy="911160"/>
            </a:xfrm>
            <a:custGeom>
              <a:avLst/>
              <a:gdLst/>
              <a:ahLst/>
              <a:rect l="l" t="t" r="r" b="b"/>
              <a:pathLst>
                <a:path w="57" h="574">
                  <a:moveTo>
                    <a:pt x="0" y="574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714040" y="344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482920" y="3579840"/>
              <a:ext cx="232920" cy="776160"/>
            </a:xfrm>
            <a:custGeom>
              <a:avLst/>
              <a:gdLst/>
              <a:ahLst/>
              <a:rect l="l" t="t" r="r" b="b"/>
              <a:pathLst>
                <a:path w="57" h="489">
                  <a:moveTo>
                    <a:pt x="0" y="489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715120" y="371484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22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482920" y="3849840"/>
              <a:ext cx="232920" cy="641160"/>
            </a:xfrm>
            <a:custGeom>
              <a:avLst/>
              <a:gdLst/>
              <a:ahLst/>
              <a:rect l="l" t="t" r="r" b="b"/>
              <a:pathLst>
                <a:path w="57" h="404">
                  <a:moveTo>
                    <a:pt x="0" y="404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710600" y="398448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14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478760" y="4119480"/>
              <a:ext cx="232200" cy="270000"/>
            </a:xfrm>
            <a:custGeom>
              <a:avLst/>
              <a:gdLst/>
              <a:ahLst/>
              <a:rect l="l" t="t" r="r" b="b"/>
              <a:pathLst>
                <a:path w="57" h="170">
                  <a:moveTo>
                    <a:pt x="0" y="170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709880" y="4254480"/>
              <a:ext cx="969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L3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478760" y="4389480"/>
              <a:ext cx="232200" cy="135000"/>
            </a:xfrm>
            <a:custGeom>
              <a:avLst/>
              <a:gdLst/>
              <a:ahLst/>
              <a:rect l="l" t="t" r="r" b="b"/>
              <a:pathLst>
                <a:path w="57" h="85">
                  <a:moveTo>
                    <a:pt x="0" y="85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709160" y="4524480"/>
              <a:ext cx="681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GB" sz="1700" spc="-1" strike="noStrike">
                  <a:solidFill>
                    <a:srgbClr val="000000"/>
                  </a:solidFill>
                  <a:latin typeface="Times New Roman"/>
                </a:rPr>
                <a:t>PoHL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478760" y="4537080"/>
              <a:ext cx="203400" cy="123840"/>
            </a:xfrm>
            <a:custGeom>
              <a:avLst/>
              <a:gdLst/>
              <a:ahLst/>
              <a:rect l="l" t="t" r="r" b="b"/>
              <a:pathLst>
                <a:path w="50" h="78">
                  <a:moveTo>
                    <a:pt x="0" y="0"/>
                  </a:moveTo>
                  <a:lnTo>
                    <a:pt x="0" y="78"/>
                  </a:lnTo>
                  <a:lnTo>
                    <a:pt x="50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478760" y="4402080"/>
              <a:ext cx="3600" cy="258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045680" y="4389480"/>
              <a:ext cx="433080" cy="406440"/>
            </a:xfrm>
            <a:custGeom>
              <a:avLst/>
              <a:gdLst/>
              <a:ahLst/>
              <a:rect l="l" t="t" r="r" b="b"/>
              <a:pathLst>
                <a:path w="106" h="256">
                  <a:moveTo>
                    <a:pt x="0" y="256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274280" y="4795920"/>
              <a:ext cx="1015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5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045680" y="4930920"/>
              <a:ext cx="228240" cy="134640"/>
            </a:xfrm>
            <a:custGeom>
              <a:avLst/>
              <a:gdLst/>
              <a:ahLst/>
              <a:rect l="l" t="t" r="r" b="b"/>
              <a:pathLst>
                <a:path w="56" h="85">
                  <a:moveTo>
                    <a:pt x="0" y="85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273560" y="5065560"/>
              <a:ext cx="907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045680" y="5076720"/>
              <a:ext cx="228240" cy="123840"/>
            </a:xfrm>
            <a:custGeom>
              <a:avLst/>
              <a:gdLst/>
              <a:ahLst/>
              <a:rect l="l" t="t" r="r" b="b"/>
              <a:pathLst>
                <a:path w="56" h="78">
                  <a:moveTo>
                    <a:pt x="0" y="0"/>
                  </a:moveTo>
                  <a:lnTo>
                    <a:pt x="0" y="78"/>
                  </a:lnTo>
                  <a:lnTo>
                    <a:pt x="56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045680" y="4807080"/>
              <a:ext cx="3600" cy="393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609000" y="4795920"/>
              <a:ext cx="436680" cy="336600"/>
            </a:xfrm>
            <a:custGeom>
              <a:avLst/>
              <a:gdLst/>
              <a:ahLst/>
              <a:rect l="l" t="t" r="r" b="b"/>
              <a:pathLst>
                <a:path w="107" h="212">
                  <a:moveTo>
                    <a:pt x="0" y="212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841560" y="533556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364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609000" y="5143680"/>
              <a:ext cx="232920" cy="326880"/>
            </a:xfrm>
            <a:custGeom>
              <a:avLst/>
              <a:gdLst/>
              <a:ahLst/>
              <a:rect l="l" t="t" r="r" b="b"/>
              <a:pathLst>
                <a:path w="57" h="206">
                  <a:moveTo>
                    <a:pt x="0" y="0"/>
                  </a:moveTo>
                  <a:lnTo>
                    <a:pt x="0" y="206"/>
                  </a:lnTo>
                  <a:lnTo>
                    <a:pt x="57" y="20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482920" y="4502160"/>
              <a:ext cx="1126080" cy="630360"/>
            </a:xfrm>
            <a:custGeom>
              <a:avLst/>
              <a:gdLst/>
              <a:ahLst/>
              <a:rect l="l" t="t" r="r" b="b"/>
              <a:pathLst>
                <a:path w="276" h="397">
                  <a:moveTo>
                    <a:pt x="0" y="0"/>
                  </a:moveTo>
                  <a:lnTo>
                    <a:pt x="0" y="397"/>
                  </a:lnTo>
                  <a:lnTo>
                    <a:pt x="276" y="39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482920" y="2882880"/>
              <a:ext cx="4320" cy="22496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6" name=""/>
          <p:cNvSpPr/>
          <p:nvPr/>
        </p:nvSpPr>
        <p:spPr>
          <a:xfrm>
            <a:off x="610200" y="2924280"/>
            <a:ext cx="41652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B31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7" name=""/>
          <p:cNvGrpSpPr/>
          <p:nvPr/>
        </p:nvGrpSpPr>
        <p:grpSpPr>
          <a:xfrm>
            <a:off x="1338840" y="6156360"/>
            <a:ext cx="429120" cy="316800"/>
            <a:chOff x="1338840" y="6156360"/>
            <a:chExt cx="429120" cy="316800"/>
          </a:xfrm>
        </p:grpSpPr>
        <p:sp>
          <p:nvSpPr>
            <p:cNvPr id="88" name=""/>
            <p:cNvSpPr/>
            <p:nvPr/>
          </p:nvSpPr>
          <p:spPr>
            <a:xfrm>
              <a:off x="1434960" y="6200640"/>
              <a:ext cx="28836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434960" y="6156360"/>
              <a:ext cx="288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723680" y="6156360"/>
              <a:ext cx="468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338840" y="6213600"/>
              <a:ext cx="42912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MS Sans Serif"/>
                </a:rPr>
                <a:t>0.05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2" name=""/>
          <p:cNvSpPr/>
          <p:nvPr/>
        </p:nvSpPr>
        <p:spPr>
          <a:xfrm flipH="1">
            <a:off x="1115640" y="3068640"/>
            <a:ext cx="13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6497280" y="425520"/>
            <a:ext cx="53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nifS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1528200" y="287496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//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3251520" y="492912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5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3683520" y="456876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8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4116600" y="420840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85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6568920" y="604188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1:39:47Z</dcterms:created>
  <dc:creator>gm250</dc:creator>
  <dc:description/>
  <dc:language>en-US</dc:language>
  <cp:lastModifiedBy>Klaus Kurtenbach</cp:lastModifiedBy>
  <dcterms:modified xsi:type="dcterms:W3CDTF">2008-12-04T16:59:40Z</dcterms:modified>
  <cp:revision>59</cp:revision>
  <dc:subject/>
  <dc:title>Slide 1</dc:title>
</cp:coreProperties>
</file>